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3.wmf" ContentType="image/x-wmf"/>
  <Override PartName="/ppt/media/image5.png" ContentType="image/png"/>
  <Override PartName="/ppt/media/image9.wmf" ContentType="image/x-wmf"/>
  <Override PartName="/ppt/media/image14.png" ContentType="image/png"/>
  <Override PartName="/ppt/media/image17.wmf" ContentType="image/x-wmf"/>
  <Override PartName="/ppt/media/image16.png" ContentType="image/png"/>
  <Override PartName="/ppt/media/image15.png" ContentType="image/png"/>
  <Override PartName="/ppt/media/image1.png" ContentType="image/png"/>
  <Override PartName="/ppt/media/image6.png" ContentType="image/png"/>
  <Override PartName="/ppt/media/image10.wmf" ContentType="image/x-wmf"/>
  <Override PartName="/ppt/media/image2.png" ContentType="image/png"/>
  <Override PartName="/ppt/media/image7.png" ContentType="image/png"/>
  <Override PartName="/ppt/media/image11.wmf" ContentType="image/x-wmf"/>
  <Override PartName="/ppt/media/image3.png" ContentType="image/png"/>
  <Override PartName="/ppt/media/image8.png" ContentType="image/png"/>
  <Override PartName="/ppt/media/image12.wmf" ContentType="image/x-wmf"/>
  <Override PartName="/ppt/media/image4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C11ACC-4712-4149-8CA2-996E1A3199F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36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1F3C86-CC14-4E5E-8AE9-2ADBB9035AE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352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2DEBA0-266A-4ADF-95B9-6E41F64BB60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28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136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28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136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78467E-ED8B-4E21-90D6-81D15B01A19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6860B2-F560-4639-BBD9-05B44C5C1FC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2670CD-BD40-4BF5-98BB-0CAAC9C8E1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BF9D70-AE2F-487D-9D9C-738359C224E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A64CCF-6F25-404B-8B48-30354A5C06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680"/>
            <a:ext cx="8228160" cy="529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24E9C4-7F11-4F6D-90A6-C933EEE05D7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ABF3E9-8317-4C86-8EE7-D01A47C305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352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6C1978-85D3-48D5-9A70-8ECE3B240D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E237E9-4CAD-400F-A45C-BE8AA6C1C6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7200" y="6245280"/>
            <a:ext cx="2131920" cy="47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3720" y="6245280"/>
            <a:ext cx="2894040" cy="47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5280"/>
            <a:ext cx="2132280" cy="47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BD887EC0-E9E9-466E-915B-277DF2203D25}" type="slidenum">
              <a:rPr b="0" lang="en-US" sz="18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9.wmf"/><Relationship Id="rId3" Type="http://schemas.openxmlformats.org/officeDocument/2006/relationships/slideLayout" Target="../slideLayouts/slideLayout1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0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11.wmf"/><Relationship Id="rId5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2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13.wmf"/><Relationship Id="rId5" Type="http://schemas.openxmlformats.org/officeDocument/2006/relationships/slideLayout" Target="../slideLayouts/slideLayout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image" Target="../media/image15.png"/><Relationship Id="rId3" Type="http://schemas.openxmlformats.org/officeDocument/2006/relationships/slideLayout" Target="../slideLayouts/slideLayout3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image" Target="../media/image17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60200" y="1830240"/>
            <a:ext cx="1568520" cy="3957840"/>
            <a:chOff x="160200" y="1830240"/>
            <a:chExt cx="1568520" cy="3957840"/>
          </a:xfrm>
        </p:grpSpPr>
        <p:pic>
          <p:nvPicPr>
            <p:cNvPr id="42" name="" descr=""/>
            <p:cNvPicPr/>
            <p:nvPr/>
          </p:nvPicPr>
          <p:blipFill>
            <a:blip r:embed="rId1"/>
            <a:stretch/>
          </p:blipFill>
          <p:spPr>
            <a:xfrm>
              <a:off x="160200" y="1830240"/>
              <a:ext cx="1568520" cy="3757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" descr=""/>
            <p:cNvPicPr/>
            <p:nvPr/>
          </p:nvPicPr>
          <p:blipFill>
            <a:blip r:embed="rId2"/>
            <a:stretch/>
          </p:blipFill>
          <p:spPr>
            <a:xfrm>
              <a:off x="192240" y="5632560"/>
              <a:ext cx="555480" cy="15552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44" name=""/>
          <p:cNvGrpSpPr/>
          <p:nvPr/>
        </p:nvGrpSpPr>
        <p:grpSpPr>
          <a:xfrm>
            <a:off x="2433600" y="1830240"/>
            <a:ext cx="922320" cy="3957840"/>
            <a:chOff x="2433600" y="1830240"/>
            <a:chExt cx="922320" cy="3957840"/>
          </a:xfrm>
        </p:grpSpPr>
        <p:pic>
          <p:nvPicPr>
            <p:cNvPr id="45" name="" descr=""/>
            <p:cNvPicPr/>
            <p:nvPr/>
          </p:nvPicPr>
          <p:blipFill>
            <a:blip r:embed="rId3"/>
            <a:stretch/>
          </p:blipFill>
          <p:spPr>
            <a:xfrm>
              <a:off x="2433600" y="1830240"/>
              <a:ext cx="922320" cy="3733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" descr=""/>
            <p:cNvPicPr/>
            <p:nvPr/>
          </p:nvPicPr>
          <p:blipFill>
            <a:blip r:embed="rId4"/>
            <a:stretch/>
          </p:blipFill>
          <p:spPr>
            <a:xfrm>
              <a:off x="2579760" y="5624640"/>
              <a:ext cx="474480" cy="16344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47" name=""/>
          <p:cNvGrpSpPr/>
          <p:nvPr/>
        </p:nvGrpSpPr>
        <p:grpSpPr>
          <a:xfrm>
            <a:off x="4178160" y="1830240"/>
            <a:ext cx="1173240" cy="3957840"/>
            <a:chOff x="4178160" y="1830240"/>
            <a:chExt cx="1173240" cy="3957840"/>
          </a:xfrm>
        </p:grpSpPr>
        <p:pic>
          <p:nvPicPr>
            <p:cNvPr id="48" name="" descr=""/>
            <p:cNvPicPr/>
            <p:nvPr/>
          </p:nvPicPr>
          <p:blipFill>
            <a:blip r:embed="rId5"/>
            <a:stretch/>
          </p:blipFill>
          <p:spPr>
            <a:xfrm>
              <a:off x="4178160" y="1830240"/>
              <a:ext cx="1173240" cy="3772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" name="" descr=""/>
            <p:cNvPicPr/>
            <p:nvPr/>
          </p:nvPicPr>
          <p:blipFill>
            <a:blip r:embed="rId6"/>
            <a:stretch/>
          </p:blipFill>
          <p:spPr>
            <a:xfrm>
              <a:off x="4408560" y="5614920"/>
              <a:ext cx="923760" cy="17316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50" name=""/>
          <p:cNvGrpSpPr/>
          <p:nvPr/>
        </p:nvGrpSpPr>
        <p:grpSpPr>
          <a:xfrm>
            <a:off x="5815080" y="1830240"/>
            <a:ext cx="3270240" cy="3957840"/>
            <a:chOff x="5815080" y="1830240"/>
            <a:chExt cx="3270240" cy="3957840"/>
          </a:xfrm>
        </p:grpSpPr>
        <p:pic>
          <p:nvPicPr>
            <p:cNvPr id="51" name="" descr=""/>
            <p:cNvPicPr/>
            <p:nvPr/>
          </p:nvPicPr>
          <p:blipFill>
            <a:blip r:embed="rId7"/>
            <a:stretch/>
          </p:blipFill>
          <p:spPr>
            <a:xfrm>
              <a:off x="5815080" y="1830240"/>
              <a:ext cx="3270240" cy="3659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" descr=""/>
            <p:cNvPicPr/>
            <p:nvPr/>
          </p:nvPicPr>
          <p:blipFill>
            <a:blip r:embed="rId8"/>
            <a:stretch/>
          </p:blipFill>
          <p:spPr>
            <a:xfrm>
              <a:off x="6443640" y="5597640"/>
              <a:ext cx="739800" cy="19044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53" name=""/>
          <p:cNvSpPr/>
          <p:nvPr/>
        </p:nvSpPr>
        <p:spPr>
          <a:xfrm>
            <a:off x="0" y="6035760"/>
            <a:ext cx="91440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1. Viral variants present in bacterial clones and PBMC virus stocks. 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able shows the calculated mean diversity among variants present in PBMC virus supernatants and bacterial clones among 4 subjects.  Maximum likelihood trees of envelopes isolated from PBMC virus stocks (black bars) and bacterial clones (white bars) among 4 subject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4" name=""/>
          <p:cNvGraphicFramePr/>
          <p:nvPr/>
        </p:nvGraphicFramePr>
        <p:xfrm>
          <a:off x="457200" y="274680"/>
          <a:ext cx="8228160" cy="1325520"/>
        </p:xfrm>
        <a:graphic>
          <a:graphicData uri="http://schemas.openxmlformats.org/drawingml/2006/table">
            <a:tbl>
              <a:tblPr/>
              <a:tblGrid>
                <a:gridCol w="1646280"/>
                <a:gridCol w="1644480"/>
                <a:gridCol w="1646280"/>
                <a:gridCol w="1644840"/>
                <a:gridCol w="1646280"/>
              </a:tblGrid>
              <a:tr h="441720"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FMI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FFP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R-5FI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R-5MP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42080"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BM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0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0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0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1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41720"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acterial clon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0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0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0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0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5" name=""/>
          <p:cNvSpPr/>
          <p:nvPr/>
        </p:nvSpPr>
        <p:spPr>
          <a:xfrm>
            <a:off x="971640" y="1886040"/>
            <a:ext cx="393480" cy="759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1123920" y="2133720"/>
            <a:ext cx="393840" cy="759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1133640" y="2371680"/>
            <a:ext cx="393480" cy="763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025640" y="2590920"/>
            <a:ext cx="393480" cy="759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981000" y="3076560"/>
            <a:ext cx="393840" cy="763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1095480" y="3314880"/>
            <a:ext cx="393480" cy="759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1057320" y="4505400"/>
            <a:ext cx="393480" cy="759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771480" y="5467320"/>
            <a:ext cx="393840" cy="763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2797200" y="1866960"/>
            <a:ext cx="393840" cy="763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2797200" y="2104920"/>
            <a:ext cx="393840" cy="763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2768760" y="2571840"/>
            <a:ext cx="393480" cy="759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2787480" y="2800440"/>
            <a:ext cx="393840" cy="759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2778120" y="3038400"/>
            <a:ext cx="393840" cy="763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2816280" y="4695840"/>
            <a:ext cx="393480" cy="763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2577960" y="4933800"/>
            <a:ext cx="393840" cy="763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2597040" y="5172120"/>
            <a:ext cx="393840" cy="763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4378320" y="1886040"/>
            <a:ext cx="393840" cy="759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4381560" y="2057400"/>
            <a:ext cx="393480" cy="763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4406760" y="2638440"/>
            <a:ext cx="393840" cy="763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4444920" y="2448000"/>
            <a:ext cx="393840" cy="759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4387680" y="2819520"/>
            <a:ext cx="393840" cy="759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4387680" y="3219480"/>
            <a:ext cx="393840" cy="763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4444920" y="3409920"/>
            <a:ext cx="393840" cy="763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4444920" y="3600360"/>
            <a:ext cx="393840" cy="763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4381560" y="3809880"/>
            <a:ext cx="393480" cy="763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4416480" y="3981600"/>
            <a:ext cx="393480" cy="759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4473720" y="4743360"/>
            <a:ext cx="393480" cy="763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4454640" y="4943520"/>
            <a:ext cx="393480" cy="763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6912000" y="1876320"/>
            <a:ext cx="393840" cy="763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6826320" y="2038320"/>
            <a:ext cx="393480" cy="763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6826320" y="2190600"/>
            <a:ext cx="393480" cy="763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6845400" y="2352600"/>
            <a:ext cx="393480" cy="763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6845400" y="2505240"/>
            <a:ext cx="393480" cy="759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6864480" y="2657520"/>
            <a:ext cx="393480" cy="763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6826320" y="2838600"/>
            <a:ext cx="393480" cy="759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6864480" y="2981160"/>
            <a:ext cx="393480" cy="763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6902280" y="3133800"/>
            <a:ext cx="393840" cy="759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6845400" y="3295800"/>
            <a:ext cx="393480" cy="759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6845400" y="3467160"/>
            <a:ext cx="393480" cy="763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6845400" y="3619440"/>
            <a:ext cx="393480" cy="763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6845400" y="3772080"/>
            <a:ext cx="393480" cy="759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6816600" y="3933720"/>
            <a:ext cx="393840" cy="763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6245280" y="5362560"/>
            <a:ext cx="393480" cy="763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1019160" y="2838600"/>
            <a:ext cx="393840" cy="759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1095480" y="3571920"/>
            <a:ext cx="39348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1133640" y="3790800"/>
            <a:ext cx="39348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1133640" y="4038480"/>
            <a:ext cx="39348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1114560" y="4276800"/>
            <a:ext cx="393480" cy="759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1057320" y="4743360"/>
            <a:ext cx="39348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1076400" y="4991040"/>
            <a:ext cx="39348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1076400" y="5229360"/>
            <a:ext cx="393480" cy="759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2797200" y="2333520"/>
            <a:ext cx="39384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2797200" y="3276720"/>
            <a:ext cx="393840" cy="759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2863800" y="3514680"/>
            <a:ext cx="39384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2835360" y="3743280"/>
            <a:ext cx="39348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2911320" y="3990960"/>
            <a:ext cx="39384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2825640" y="4229280"/>
            <a:ext cx="393840" cy="759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2720880" y="4448160"/>
            <a:ext cx="39384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2590920" y="5410080"/>
            <a:ext cx="39348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4473720" y="3019320"/>
            <a:ext cx="39348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4397400" y="2266920"/>
            <a:ext cx="39384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4444920" y="4191120"/>
            <a:ext cx="393840" cy="759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4464000" y="4362480"/>
            <a:ext cx="39384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4616280" y="4572000"/>
            <a:ext cx="39384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4645080" y="5324400"/>
            <a:ext cx="39348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4616280" y="5514840"/>
            <a:ext cx="39384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4616280" y="5133960"/>
            <a:ext cx="39384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8569440" y="4095720"/>
            <a:ext cx="39348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6912000" y="4238640"/>
            <a:ext cx="39384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6245280" y="5200560"/>
            <a:ext cx="39348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6905520" y="4410000"/>
            <a:ext cx="39384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7074000" y="4572000"/>
            <a:ext cx="39348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7169040" y="4886280"/>
            <a:ext cx="39384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7207200" y="4724280"/>
            <a:ext cx="39384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6988320" y="5038560"/>
            <a:ext cx="393480" cy="763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672120" y="5599080"/>
            <a:ext cx="552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HFM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2492640" y="5745240"/>
            <a:ext cx="578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HFF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4668840" y="5715000"/>
            <a:ext cx="663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R-5F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6987600" y="5334120"/>
            <a:ext cx="756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R-5M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4" name=""/>
          <p:cNvGraphicFramePr/>
          <p:nvPr/>
        </p:nvGraphicFramePr>
        <p:xfrm>
          <a:off x="1981080" y="1066680"/>
          <a:ext cx="4591080" cy="31989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35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981080" y="1066680"/>
                    <a:ext cx="4591080" cy="3198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36" name=""/>
          <p:cNvSpPr/>
          <p:nvPr/>
        </p:nvSpPr>
        <p:spPr>
          <a:xfrm>
            <a:off x="2520" y="0"/>
            <a:ext cx="2849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Pena-Cruz et. al. Supplementary figure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152280" y="4952880"/>
            <a:ext cx="87631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2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xtensive replication variation in cells from different blood donation volunteers. 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ox plot shows infectious virus AUC in activated CD4+ T cells from 4 different blood donation volunteers.  Level of replication was statistically different among the cells from different donors (p &lt; 0.0001) (Kruskal Wallis Test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8" name=""/>
          <p:cNvGrpSpPr/>
          <p:nvPr/>
        </p:nvGrpSpPr>
        <p:grpSpPr>
          <a:xfrm>
            <a:off x="-28440" y="1981080"/>
            <a:ext cx="4451040" cy="3218040"/>
            <a:chOff x="-28440" y="1981080"/>
            <a:chExt cx="4451040" cy="3218040"/>
          </a:xfrm>
        </p:grpSpPr>
        <p:graphicFrame>
          <p:nvGraphicFramePr>
            <p:cNvPr id="139" name=""/>
            <p:cNvGraphicFramePr/>
            <p:nvPr/>
          </p:nvGraphicFramePr>
          <p:xfrm>
            <a:off x="-28440" y="2081160"/>
            <a:ext cx="4451040" cy="311796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140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-28440" y="2081160"/>
                      <a:ext cx="4451040" cy="31179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pSp>
          <p:nvGrpSpPr>
            <p:cNvPr id="141" name=""/>
            <p:cNvGrpSpPr/>
            <p:nvPr/>
          </p:nvGrpSpPr>
          <p:grpSpPr>
            <a:xfrm>
              <a:off x="808560" y="1981080"/>
              <a:ext cx="3555720" cy="2795400"/>
              <a:chOff x="808560" y="1981080"/>
              <a:chExt cx="3555720" cy="2795400"/>
            </a:xfrm>
          </p:grpSpPr>
          <p:sp>
            <p:nvSpPr>
              <p:cNvPr id="142" name=""/>
              <p:cNvSpPr/>
              <p:nvPr/>
            </p:nvSpPr>
            <p:spPr>
              <a:xfrm>
                <a:off x="965880" y="4530240"/>
                <a:ext cx="349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HF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1298520" y="4530240"/>
                <a:ext cx="390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88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>
                <a:off x="1671480" y="4530240"/>
                <a:ext cx="390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89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2062080" y="4530240"/>
                <a:ext cx="390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39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>
                <a:off x="2427120" y="4530240"/>
                <a:ext cx="390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927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>
                <a:off x="2767320" y="4530240"/>
                <a:ext cx="461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2769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>
                <a:off x="3116520" y="4530240"/>
                <a:ext cx="461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281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>
                <a:off x="3493800" y="4530240"/>
                <a:ext cx="4262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SR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>
                <a:off x="3868200" y="4530240"/>
                <a:ext cx="496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SR2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>
                <a:off x="808560" y="1981080"/>
                <a:ext cx="3452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Arial"/>
                  </a:rPr>
                  <a:t>A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52" name=""/>
          <p:cNvSpPr/>
          <p:nvPr/>
        </p:nvSpPr>
        <p:spPr>
          <a:xfrm>
            <a:off x="2520" y="0"/>
            <a:ext cx="2849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Pena-Cruz et. al. Supplementary figure 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3" name=""/>
          <p:cNvGrpSpPr/>
          <p:nvPr/>
        </p:nvGrpSpPr>
        <p:grpSpPr>
          <a:xfrm>
            <a:off x="4233960" y="1981080"/>
            <a:ext cx="4451400" cy="3217680"/>
            <a:chOff x="4233960" y="1981080"/>
            <a:chExt cx="4451400" cy="3217680"/>
          </a:xfrm>
        </p:grpSpPr>
        <p:graphicFrame>
          <p:nvGraphicFramePr>
            <p:cNvPr id="154" name=""/>
            <p:cNvGraphicFramePr/>
            <p:nvPr/>
          </p:nvGraphicFramePr>
          <p:xfrm>
            <a:off x="4233960" y="2087640"/>
            <a:ext cx="4451400" cy="311112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155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4233960" y="2087640"/>
                      <a:ext cx="4451400" cy="31111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pSp>
          <p:nvGrpSpPr>
            <p:cNvPr id="156" name=""/>
            <p:cNvGrpSpPr/>
            <p:nvPr/>
          </p:nvGrpSpPr>
          <p:grpSpPr>
            <a:xfrm>
              <a:off x="5075640" y="1981080"/>
              <a:ext cx="3549240" cy="2795400"/>
              <a:chOff x="5075640" y="1981080"/>
              <a:chExt cx="3549240" cy="2795400"/>
            </a:xfrm>
          </p:grpSpPr>
          <p:sp>
            <p:nvSpPr>
              <p:cNvPr id="157" name=""/>
              <p:cNvSpPr/>
              <p:nvPr/>
            </p:nvSpPr>
            <p:spPr>
              <a:xfrm>
                <a:off x="5229360" y="4530240"/>
                <a:ext cx="349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HF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"/>
              <p:cNvSpPr/>
              <p:nvPr/>
            </p:nvSpPr>
            <p:spPr>
              <a:xfrm>
                <a:off x="5562000" y="4530240"/>
                <a:ext cx="390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88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>
                <a:off x="5934600" y="4530240"/>
                <a:ext cx="390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89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"/>
              <p:cNvSpPr/>
              <p:nvPr/>
            </p:nvSpPr>
            <p:spPr>
              <a:xfrm>
                <a:off x="6325200" y="4530240"/>
                <a:ext cx="390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39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>
                <a:off x="6689880" y="4530240"/>
                <a:ext cx="390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927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>
                <a:off x="7028280" y="4530240"/>
                <a:ext cx="461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2769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>
                <a:off x="7378920" y="4530240"/>
                <a:ext cx="461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281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>
                <a:off x="7754760" y="4530240"/>
                <a:ext cx="4262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SR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8128800" y="4530240"/>
                <a:ext cx="496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SR2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"/>
              <p:cNvSpPr/>
              <p:nvPr/>
            </p:nvSpPr>
            <p:spPr>
              <a:xfrm>
                <a:off x="5075640" y="1981080"/>
                <a:ext cx="3452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  <a:tab algn="l" pos="105156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67" name=""/>
          <p:cNvGrpSpPr/>
          <p:nvPr/>
        </p:nvGrpSpPr>
        <p:grpSpPr>
          <a:xfrm>
            <a:off x="1600200" y="1949400"/>
            <a:ext cx="2477160" cy="642960"/>
            <a:chOff x="1600200" y="1949400"/>
            <a:chExt cx="2477160" cy="642960"/>
          </a:xfrm>
        </p:grpSpPr>
        <p:sp>
          <p:nvSpPr>
            <p:cNvPr id="168" name=""/>
            <p:cNvSpPr/>
            <p:nvPr/>
          </p:nvSpPr>
          <p:spPr>
            <a:xfrm>
              <a:off x="1724760" y="1949400"/>
              <a:ext cx="23526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Newly infected partner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1732320" y="2255040"/>
              <a:ext cx="21603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5156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Transmitting partner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1600200" y="2044800"/>
              <a:ext cx="150840" cy="151200"/>
            </a:xfrm>
            <a:prstGeom prst="rect">
              <a:avLst/>
            </a:prstGeom>
            <a:solidFill>
              <a:srgbClr val="808080"/>
            </a:solidFill>
            <a:ln cap="sq"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1609560" y="2341080"/>
              <a:ext cx="150840" cy="151200"/>
            </a:xfrm>
            <a:prstGeom prst="rect">
              <a:avLst/>
            </a:prstGeom>
            <a:solidFill>
              <a:srgbClr val="000000"/>
            </a:solidFill>
            <a:ln cap="sq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2" name=""/>
          <p:cNvSpPr/>
          <p:nvPr/>
        </p:nvSpPr>
        <p:spPr>
          <a:xfrm>
            <a:off x="0" y="5334120"/>
            <a:ext cx="91440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3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Replication in MDDC cultures without CD4+ T cells. 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Graph A and B show infectious virus AUC in immature (A) and mature (B) MDDCs without CD4+ T cells among recipient (gray bar) and transmitter (black bar) envelope viruses. Replication in MDDCs alone was tested in cells from 3 different blood donation volunteers, and only observed in 1 of the 3 blood donation volunteer’s cells.  The x-axis shows the couple I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3" name=""/>
          <p:cNvGraphicFramePr/>
          <p:nvPr/>
        </p:nvGraphicFramePr>
        <p:xfrm>
          <a:off x="0" y="2362320"/>
          <a:ext cx="4591080" cy="31986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74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0" y="2362320"/>
                    <a:ext cx="4591080" cy="3198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75" name=""/>
          <p:cNvGraphicFramePr/>
          <p:nvPr/>
        </p:nvGraphicFramePr>
        <p:xfrm>
          <a:off x="4552920" y="2362320"/>
          <a:ext cx="4591080" cy="319860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176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4552920" y="2362320"/>
                    <a:ext cx="4591080" cy="3198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77" name=""/>
          <p:cNvSpPr/>
          <p:nvPr/>
        </p:nvSpPr>
        <p:spPr>
          <a:xfrm>
            <a:off x="720" y="2209680"/>
            <a:ext cx="3909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ahoma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4880160" y="2209680"/>
            <a:ext cx="3848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ahoma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2520" y="0"/>
            <a:ext cx="2849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Pena-Cruz et. al. Supplementary figure 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0" y="5638680"/>
            <a:ext cx="91440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4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xtensive replication variation in cells from different blood donors. 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ox plots show infectious virus AUC in immature MDDCs – autologous CD4+ T cells (A) and mature MDDCs – autologous CD4+ T cells (B) from 4 different blood donation volunteers.  Level of replication was statistically different among the activated CD4+ T cell co-cultures with immature MDDCs (p = 0.01), and mature MDDCs from different donors (p = 0.0004) (Kruskal Wallis Test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1" name="" descr=""/>
          <p:cNvPicPr/>
          <p:nvPr/>
        </p:nvPicPr>
        <p:blipFill>
          <a:blip r:embed="rId1"/>
          <a:stretch/>
        </p:blipFill>
        <p:spPr>
          <a:xfrm>
            <a:off x="4478400" y="944640"/>
            <a:ext cx="3462120" cy="3504960"/>
          </a:xfrm>
          <a:prstGeom prst="rect">
            <a:avLst/>
          </a:prstGeom>
          <a:ln w="0">
            <a:noFill/>
          </a:ln>
        </p:spPr>
      </p:pic>
      <p:pic>
        <p:nvPicPr>
          <p:cNvPr id="182" name="" descr=""/>
          <p:cNvPicPr/>
          <p:nvPr/>
        </p:nvPicPr>
        <p:blipFill>
          <a:blip r:embed="rId2"/>
          <a:stretch/>
        </p:blipFill>
        <p:spPr>
          <a:xfrm>
            <a:off x="0" y="914400"/>
            <a:ext cx="3436920" cy="3419640"/>
          </a:xfrm>
          <a:prstGeom prst="rect">
            <a:avLst/>
          </a:prstGeom>
          <a:ln w="0">
            <a:noFill/>
          </a:ln>
        </p:spPr>
      </p:pic>
      <p:sp>
        <p:nvSpPr>
          <p:cNvPr id="183" name=""/>
          <p:cNvSpPr/>
          <p:nvPr/>
        </p:nvSpPr>
        <p:spPr>
          <a:xfrm>
            <a:off x="3429000" y="2544840"/>
            <a:ext cx="1025640" cy="1440"/>
          </a:xfrm>
          <a:prstGeom prst="line">
            <a:avLst/>
          </a:prstGeom>
          <a:ln cap="sq" w="572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6672960" y="1339920"/>
            <a:ext cx="636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91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4951800" y="1349280"/>
            <a:ext cx="700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0.4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901800" y="1096920"/>
            <a:ext cx="113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kin LC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4954320" y="4313160"/>
            <a:ext cx="1146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Langer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 rot="16200000">
            <a:off x="4284360" y="3584880"/>
            <a:ext cx="762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D1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6095880" y="4497480"/>
            <a:ext cx="1295640" cy="1440"/>
          </a:xfrm>
          <a:prstGeom prst="line">
            <a:avLst/>
          </a:prstGeom>
          <a:ln cap="sq"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 flipV="1">
            <a:off x="4662360" y="2071440"/>
            <a:ext cx="1800" cy="1298520"/>
          </a:xfrm>
          <a:prstGeom prst="line">
            <a:avLst/>
          </a:prstGeom>
          <a:ln cap="sq"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2520" y="-1440"/>
            <a:ext cx="2849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Pena-Cruz et. al. Supplementary figure 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0" y="5029200"/>
            <a:ext cx="914400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5.  Flow cytometric analysis of Langerhans cells isolated from discarded mammoplasty tissue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After discontinuous Opti-Prep gradient and CD1a magnetic bead isolation, cells were examined for CD1a and langerin expression.  Cells were stained for CD1a-FITC (Thermo Scientific, Rockford, IL, USA) and langerin (CD207)-PE (Immunotech, Marseille, France) respectively.  This is a representative example of LC isolation from multiple independent mammoplasty tissue. Flow cytometry was performed using a BD FACSCanto II and analyzed on BD FACSDiva software (Becton Dickinson, San Jose, CA); and on a Cytomics FC500 (Beckman Coulter, Fullerton, CA) and analyzed with FlowJo software (Tree Star, Ashland, OR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"/>
          <p:cNvSpPr/>
          <p:nvPr/>
        </p:nvSpPr>
        <p:spPr>
          <a:xfrm>
            <a:off x="762120" y="457200"/>
            <a:ext cx="3200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CD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4876920" y="457200"/>
            <a:ext cx="3200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CD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5040" y="1440"/>
            <a:ext cx="2891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Pena-Cruz et. al. Supplementary Figure 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607680" y="4716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2487240" y="25765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98" name="" descr=""/>
          <p:cNvPicPr/>
          <p:nvPr/>
        </p:nvPicPr>
        <p:blipFill>
          <a:blip r:embed="rId1"/>
          <a:stretch/>
        </p:blipFill>
        <p:spPr>
          <a:xfrm>
            <a:off x="76320" y="739800"/>
            <a:ext cx="3879720" cy="3852720"/>
          </a:xfrm>
          <a:prstGeom prst="rect">
            <a:avLst/>
          </a:prstGeom>
          <a:ln w="0">
            <a:noFill/>
          </a:ln>
        </p:spPr>
      </p:pic>
      <p:pic>
        <p:nvPicPr>
          <p:cNvPr id="199" name="" descr=""/>
          <p:cNvPicPr/>
          <p:nvPr/>
        </p:nvPicPr>
        <p:blipFill>
          <a:blip r:embed="rId2"/>
          <a:stretch/>
        </p:blipFill>
        <p:spPr>
          <a:xfrm>
            <a:off x="4378320" y="765000"/>
            <a:ext cx="3699000" cy="3807000"/>
          </a:xfrm>
          <a:prstGeom prst="rect">
            <a:avLst/>
          </a:prstGeom>
          <a:ln w="0">
            <a:noFill/>
          </a:ln>
        </p:spPr>
      </p:pic>
      <p:sp>
        <p:nvSpPr>
          <p:cNvPr id="200" name=""/>
          <p:cNvSpPr/>
          <p:nvPr/>
        </p:nvSpPr>
        <p:spPr>
          <a:xfrm>
            <a:off x="3352680" y="4648320"/>
            <a:ext cx="152640" cy="1440"/>
          </a:xfrm>
          <a:prstGeom prst="line">
            <a:avLst/>
          </a:prstGeom>
          <a:ln cap="sq"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3352680" y="4876920"/>
            <a:ext cx="152640" cy="1440"/>
          </a:xfrm>
          <a:prstGeom prst="line">
            <a:avLst/>
          </a:prstGeom>
          <a:ln cap="sq" w="381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3352680" y="5105520"/>
            <a:ext cx="152640" cy="1440"/>
          </a:xfrm>
          <a:prstGeom prst="line">
            <a:avLst/>
          </a:prstGeom>
          <a:ln cap="sq"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>
            <a:off x="3352680" y="5334120"/>
            <a:ext cx="152640" cy="1440"/>
          </a:xfrm>
          <a:prstGeom prst="line">
            <a:avLst/>
          </a:prstGeom>
          <a:ln cap="sq" w="38160">
            <a:solidFill>
              <a:srgbClr val="261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3431520" y="4470480"/>
            <a:ext cx="3163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RA neg. cells with isotype contro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3429360" y="4692600"/>
            <a:ext cx="3152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RA pos. cells with isotype contro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3411360" y="4826160"/>
            <a:ext cx="53442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RA neg. cells with anti-mouse integrin β7 antibody (clone FIB27)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>
            <a:off x="3410640" y="5057640"/>
            <a:ext cx="53348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RA pos. cells with anti-mouse integrin β7 antibody (clone FIB27)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>
            <a:off x="4916160" y="4572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>
            <a:off x="0" y="5562720"/>
            <a:ext cx="914400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6.  Retinoic acid treatment increases α4β7 expression. 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istograms show integrin α4β7 mean fluorescence intensity on CD4+ (A) and CD8+ (B) T cells that were cultured with or without retinoic acid for a minimum of 6 days. Surface α4β7 integrin expression was probed with phyocoerythrin (PE) conjugated anti-mouse integrin β7 antibody (clone FIB27) (BioLegend).  Each graph also shows staining of RA unexposed and RA exposed cells to an isotype control antibody. This is a representative example from multiple independent experiment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7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3-08T21:17:29Z</dcterms:created>
  <dc:creator>BMC</dc:creator>
  <dc:description/>
  <dc:language>en-US</dc:language>
  <cp:lastModifiedBy>BMC</cp:lastModifiedBy>
  <dcterms:modified xsi:type="dcterms:W3CDTF">2013-12-04T20:57:30Z</dcterms:modified>
  <cp:revision>10</cp:revision>
  <dc:subject/>
  <dc:title>Slide 1</dc:title>
</cp:coreProperties>
</file>